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F34F97-7DBA-49FA-AF5F-0E073C3CEA6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C5E02D-7CF4-49DF-8124-06EAC13416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138F3A-B191-4562-BCCE-7DCEE577E05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5E28EA-3BAF-4A1C-8DAD-6AA7C1CA2E7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EF6E91-D0FE-4E9A-9AF1-4F7952147DF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B83198-203B-4A49-A8D7-6A154C4FF3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5EFBA1-6B22-4AA1-AB0B-114AE7199B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1C5936-E00E-4CD6-BD8A-FA48843573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EAEF35-68B0-45BB-A11F-86C06C6E2CD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E338B9-0884-4E07-902D-5ED2A67B82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B3B8BB-F160-4A4F-921F-38C9749705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415971-1214-4D3C-95B5-DFD3C6ECC2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19800"/>
            <a:ext cx="160020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19800"/>
            <a:ext cx="217152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19800"/>
            <a:ext cx="160020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4C4F08A-0389-4FE8-BBBD-80C71BB8096F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ttangolo 1"/>
          <p:cNvSpPr/>
          <p:nvPr/>
        </p:nvSpPr>
        <p:spPr>
          <a:xfrm>
            <a:off x="579600" y="5554800"/>
            <a:ext cx="579420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: Monosaccharide composition of the ChASS fraction of cell walls from WT (Col-0), </a:t>
            </a:r>
            <a:r>
              <a:rPr b="1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ua2-1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</a:t>
            </a:r>
            <a:r>
              <a:rPr b="1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me3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PG and PMEI plants.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onosaccharide composition was determined by high-performance anion-exchange chromatography with pulsed amperometric detection (HPAEC-PAD). Values are expressed in % mol for each monosaccharide. Bars represent means ± SE; (n = 4); Different letters indicate statistically significant differences in each monosaccharides between mutants or transgenic plants and WT plants, according to ANOVA followed by Tukey’s test (P &lt;0.05)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uppo 3"/>
          <p:cNvGrpSpPr/>
          <p:nvPr/>
        </p:nvGrpSpPr>
        <p:grpSpPr>
          <a:xfrm>
            <a:off x="712800" y="1803240"/>
            <a:ext cx="5489640" cy="3335400"/>
            <a:chOff x="712800" y="1803240"/>
            <a:chExt cx="5489640" cy="3335400"/>
          </a:xfrm>
        </p:grpSpPr>
        <p:pic>
          <p:nvPicPr>
            <p:cNvPr id="43" name="Grafico 178" descr=""/>
            <p:cNvPicPr/>
            <p:nvPr/>
          </p:nvPicPr>
          <p:blipFill>
            <a:blip r:embed="rId1"/>
            <a:stretch/>
          </p:blipFill>
          <p:spPr>
            <a:xfrm>
              <a:off x="712800" y="1803240"/>
              <a:ext cx="5489640" cy="3335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CasellaDiTesto 1"/>
            <p:cNvSpPr/>
            <p:nvPr/>
          </p:nvSpPr>
          <p:spPr>
            <a:xfrm>
              <a:off x="2545920" y="400752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CasellaDiTesto 180"/>
            <p:cNvSpPr/>
            <p:nvPr/>
          </p:nvSpPr>
          <p:spPr>
            <a:xfrm>
              <a:off x="2722320" y="395748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CasellaDiTesto 181"/>
            <p:cNvSpPr/>
            <p:nvPr/>
          </p:nvSpPr>
          <p:spPr>
            <a:xfrm>
              <a:off x="2634480" y="400068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CasellaDiTesto 182"/>
            <p:cNvSpPr/>
            <p:nvPr/>
          </p:nvSpPr>
          <p:spPr>
            <a:xfrm>
              <a:off x="2912040" y="385488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CasellaDiTesto 183"/>
            <p:cNvSpPr/>
            <p:nvPr/>
          </p:nvSpPr>
          <p:spPr>
            <a:xfrm>
              <a:off x="2819880" y="374796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CasellaDiTesto 184"/>
            <p:cNvSpPr/>
            <p:nvPr/>
          </p:nvSpPr>
          <p:spPr>
            <a:xfrm>
              <a:off x="3149280" y="415332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CasellaDiTesto 185"/>
            <p:cNvSpPr/>
            <p:nvPr/>
          </p:nvSpPr>
          <p:spPr>
            <a:xfrm>
              <a:off x="3325680" y="408240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CasellaDiTesto 186"/>
            <p:cNvSpPr/>
            <p:nvPr/>
          </p:nvSpPr>
          <p:spPr>
            <a:xfrm>
              <a:off x="3237840" y="414648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CasellaDiTesto 187"/>
            <p:cNvSpPr/>
            <p:nvPr/>
          </p:nvSpPr>
          <p:spPr>
            <a:xfrm>
              <a:off x="3515400" y="405648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CasellaDiTesto 188"/>
            <p:cNvSpPr/>
            <p:nvPr/>
          </p:nvSpPr>
          <p:spPr>
            <a:xfrm>
              <a:off x="3423240" y="399456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CasellaDiTesto 189"/>
            <p:cNvSpPr/>
            <p:nvPr/>
          </p:nvSpPr>
          <p:spPr>
            <a:xfrm>
              <a:off x="3747240" y="456624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CasellaDiTesto 190"/>
            <p:cNvSpPr/>
            <p:nvPr/>
          </p:nvSpPr>
          <p:spPr>
            <a:xfrm>
              <a:off x="3923640" y="456156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CasellaDiTesto 191"/>
            <p:cNvSpPr/>
            <p:nvPr/>
          </p:nvSpPr>
          <p:spPr>
            <a:xfrm>
              <a:off x="3835440" y="456156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CasellaDiTesto 192"/>
            <p:cNvSpPr/>
            <p:nvPr/>
          </p:nvSpPr>
          <p:spPr>
            <a:xfrm>
              <a:off x="4113360" y="456156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CasellaDiTesto 193"/>
            <p:cNvSpPr/>
            <p:nvPr/>
          </p:nvSpPr>
          <p:spPr>
            <a:xfrm>
              <a:off x="4021200" y="456156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CasellaDiTesto 194"/>
            <p:cNvSpPr/>
            <p:nvPr/>
          </p:nvSpPr>
          <p:spPr>
            <a:xfrm>
              <a:off x="1334880" y="460044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CasellaDiTesto 195"/>
            <p:cNvSpPr/>
            <p:nvPr/>
          </p:nvSpPr>
          <p:spPr>
            <a:xfrm>
              <a:off x="1511280" y="459576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CasellaDiTesto 196"/>
            <p:cNvSpPr/>
            <p:nvPr/>
          </p:nvSpPr>
          <p:spPr>
            <a:xfrm>
              <a:off x="1423080" y="459576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CasellaDiTesto 197"/>
            <p:cNvSpPr/>
            <p:nvPr/>
          </p:nvSpPr>
          <p:spPr>
            <a:xfrm>
              <a:off x="1701000" y="459576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CasellaDiTesto 198"/>
            <p:cNvSpPr/>
            <p:nvPr/>
          </p:nvSpPr>
          <p:spPr>
            <a:xfrm>
              <a:off x="1608840" y="459576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CasellaDiTesto 199"/>
            <p:cNvSpPr/>
            <p:nvPr/>
          </p:nvSpPr>
          <p:spPr>
            <a:xfrm>
              <a:off x="1929600" y="390672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CasellaDiTesto 200"/>
            <p:cNvSpPr/>
            <p:nvPr/>
          </p:nvSpPr>
          <p:spPr>
            <a:xfrm>
              <a:off x="2126520" y="391356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CasellaDiTesto 201"/>
            <p:cNvSpPr/>
            <p:nvPr/>
          </p:nvSpPr>
          <p:spPr>
            <a:xfrm>
              <a:off x="2039400" y="389412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CasellaDiTesto 202"/>
            <p:cNvSpPr/>
            <p:nvPr/>
          </p:nvSpPr>
          <p:spPr>
            <a:xfrm>
              <a:off x="2304720" y="396936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CasellaDiTesto 203"/>
            <p:cNvSpPr/>
            <p:nvPr/>
          </p:nvSpPr>
          <p:spPr>
            <a:xfrm>
              <a:off x="2218320" y="396792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CasellaDiTesto 204"/>
            <p:cNvSpPr/>
            <p:nvPr/>
          </p:nvSpPr>
          <p:spPr>
            <a:xfrm>
              <a:off x="4350600" y="409608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CasellaDiTesto 205"/>
            <p:cNvSpPr/>
            <p:nvPr/>
          </p:nvSpPr>
          <p:spPr>
            <a:xfrm>
              <a:off x="4533480" y="409140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CasellaDiTesto 206"/>
            <p:cNvSpPr/>
            <p:nvPr/>
          </p:nvSpPr>
          <p:spPr>
            <a:xfrm>
              <a:off x="4438800" y="413352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CasellaDiTesto 207"/>
            <p:cNvSpPr/>
            <p:nvPr/>
          </p:nvSpPr>
          <p:spPr>
            <a:xfrm>
              <a:off x="4716720" y="395172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CasellaDiTesto 208"/>
            <p:cNvSpPr/>
            <p:nvPr/>
          </p:nvSpPr>
          <p:spPr>
            <a:xfrm>
              <a:off x="4624560" y="395172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CasellaDiTesto 209"/>
            <p:cNvSpPr/>
            <p:nvPr/>
          </p:nvSpPr>
          <p:spPr>
            <a:xfrm>
              <a:off x="4956840" y="201600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CasellaDiTesto 210"/>
            <p:cNvSpPr/>
            <p:nvPr/>
          </p:nvSpPr>
          <p:spPr>
            <a:xfrm>
              <a:off x="5133600" y="203400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CasellaDiTesto 211"/>
            <p:cNvSpPr/>
            <p:nvPr/>
          </p:nvSpPr>
          <p:spPr>
            <a:xfrm>
              <a:off x="5051880" y="210960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CasellaDiTesto 212"/>
            <p:cNvSpPr/>
            <p:nvPr/>
          </p:nvSpPr>
          <p:spPr>
            <a:xfrm>
              <a:off x="5335920" y="244548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CasellaDiTesto 213"/>
            <p:cNvSpPr/>
            <p:nvPr/>
          </p:nvSpPr>
          <p:spPr>
            <a:xfrm>
              <a:off x="5237280" y="259236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CasellaDiTesto 214"/>
            <p:cNvSpPr/>
            <p:nvPr/>
          </p:nvSpPr>
          <p:spPr>
            <a:xfrm>
              <a:off x="5556960" y="454536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CasellaDiTesto 215"/>
            <p:cNvSpPr/>
            <p:nvPr/>
          </p:nvSpPr>
          <p:spPr>
            <a:xfrm>
              <a:off x="5733360" y="454068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CasellaDiTesto 216"/>
            <p:cNvSpPr/>
            <p:nvPr/>
          </p:nvSpPr>
          <p:spPr>
            <a:xfrm>
              <a:off x="5645160" y="454068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CasellaDiTesto 217"/>
            <p:cNvSpPr/>
            <p:nvPr/>
          </p:nvSpPr>
          <p:spPr>
            <a:xfrm>
              <a:off x="5923080" y="454068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CasellaDiTesto 218"/>
            <p:cNvSpPr/>
            <p:nvPr/>
          </p:nvSpPr>
          <p:spPr>
            <a:xfrm>
              <a:off x="5830560" y="454068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63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09T23:56:23Z</dcterms:created>
  <dc:creator>Utenti</dc:creator>
  <dc:description/>
  <dc:language>en-US</dc:language>
  <cp:lastModifiedBy>Daniela Bellincampi</cp:lastModifiedBy>
  <cp:lastPrinted>2013-07-05T13:42:32Z</cp:lastPrinted>
  <dcterms:modified xsi:type="dcterms:W3CDTF">2013-07-31T14:37:24Z</dcterms:modified>
  <cp:revision>283</cp:revision>
  <dc:subject/>
  <dc:title>Diapositiva 1</dc:title>
</cp:coreProperties>
</file>